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1104" y="269"/>
      </p:cViewPr>
      <p:guideLst>
        <p:guide orient="horz" pos="1236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45005" cy="450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Arkusz_programu_Microsoft_Excel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Arkusz_programu_Microsoft_Excel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Arkusz_programu_Microsoft_Excel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Arkusz_programu_Microsoft_Excel4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1297025371828524"/>
          <c:y val="0.1252027030068926"/>
          <c:w val="0.65553868266466697"/>
          <c:h val="0.5044668944683801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Other ABCs'!$N$3:$N$6</c:f>
                <c:numCache>
                  <c:formatCode>General</c:formatCode>
                  <c:ptCount val="4"/>
                  <c:pt idx="0">
                    <c:v>0.10944845807350238</c:v>
                  </c:pt>
                  <c:pt idx="1">
                    <c:v>6.7740583055238279E-2</c:v>
                  </c:pt>
                  <c:pt idx="2">
                    <c:v>0.14370399520246807</c:v>
                  </c:pt>
                  <c:pt idx="3">
                    <c:v>0.33984458721061578</c:v>
                  </c:pt>
                </c:numCache>
              </c:numRef>
            </c:plus>
            <c:minus>
              <c:numRef>
                <c:f>'Other ABCs'!$N$3:$N$6</c:f>
                <c:numCache>
                  <c:formatCode>General</c:formatCode>
                  <c:ptCount val="4"/>
                  <c:pt idx="0">
                    <c:v>0.10944845807350238</c:v>
                  </c:pt>
                  <c:pt idx="1">
                    <c:v>6.7740583055238279E-2</c:v>
                  </c:pt>
                  <c:pt idx="2">
                    <c:v>0.14370399520246807</c:v>
                  </c:pt>
                  <c:pt idx="3">
                    <c:v>0.33984458721061578</c:v>
                  </c:pt>
                </c:numCache>
              </c:numRef>
            </c:minus>
          </c:errBars>
          <c:cat>
            <c:strRef>
              <c:f>'Other ABCs'!$C$3:$C$6</c:f>
              <c:strCache>
                <c:ptCount val="4"/>
                <c:pt idx="0">
                  <c:v>-</c:v>
                </c:pt>
                <c:pt idx="1">
                  <c:v>Cispl</c:v>
                </c:pt>
                <c:pt idx="2">
                  <c:v>iHDAC</c:v>
                </c:pt>
                <c:pt idx="3">
                  <c:v>Cispl + iHDAC</c:v>
                </c:pt>
              </c:strCache>
            </c:strRef>
          </c:cat>
          <c:val>
            <c:numRef>
              <c:f>'Other ABCs'!$J$3:$J$6</c:f>
              <c:numCache>
                <c:formatCode>0\.0000</c:formatCode>
                <c:ptCount val="4"/>
                <c:pt idx="0">
                  <c:v>0.99933176034199589</c:v>
                </c:pt>
                <c:pt idx="1">
                  <c:v>0.68512887877715334</c:v>
                </c:pt>
                <c:pt idx="2">
                  <c:v>0.59869752162329504</c:v>
                </c:pt>
                <c:pt idx="3">
                  <c:v>1.86357816499796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0719232"/>
        <c:axId val="80731520"/>
      </c:barChart>
      <c:catAx>
        <c:axId val="8071923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txPr>
          <a:bodyPr rot="-2700000"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pl-PL"/>
          </a:p>
        </c:txPr>
        <c:crossAx val="80731520"/>
        <c:crosses val="autoZero"/>
        <c:auto val="1"/>
        <c:lblAlgn val="ctr"/>
        <c:lblOffset val="100"/>
        <c:noMultiLvlLbl val="0"/>
      </c:catAx>
      <c:valAx>
        <c:axId val="80731520"/>
        <c:scaling>
          <c:orientation val="minMax"/>
          <c:max val="2.4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pl-PL"/>
                  <a:t>Fold</a:t>
                </a:r>
                <a:r>
                  <a:rPr lang="pl-PL" baseline="0"/>
                  <a:t> change</a:t>
                </a:r>
                <a:endParaRPr lang="pl-PL"/>
              </a:p>
            </c:rich>
          </c:tx>
          <c:layout>
            <c:manualLayout>
              <c:xMode val="edge"/>
              <c:yMode val="edge"/>
              <c:x val="6.7597800274965631E-3"/>
              <c:y val="0.19986704932911423"/>
            </c:manualLayout>
          </c:layout>
          <c:overlay val="0"/>
        </c:title>
        <c:numFmt formatCode="#,##0.0" sourceLinked="0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txPr>
          <a:bodyPr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pl-PL"/>
          </a:p>
        </c:txPr>
        <c:crossAx val="80719232"/>
        <c:crosses val="autoZero"/>
        <c:crossBetween val="between"/>
        <c:majorUnit val="0.8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1297025371828524"/>
          <c:y val="0.1252027030068926"/>
          <c:w val="0.65553868266466697"/>
          <c:h val="0.5044668944683801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Other ABCs'!$N$13:$N$16</c:f>
                <c:numCache>
                  <c:formatCode>General</c:formatCode>
                  <c:ptCount val="4"/>
                  <c:pt idx="0">
                    <c:v>8.2121770396226465E-2</c:v>
                  </c:pt>
                  <c:pt idx="1">
                    <c:v>0.10313214910994892</c:v>
                  </c:pt>
                  <c:pt idx="2">
                    <c:v>0.26857802761922173</c:v>
                  </c:pt>
                  <c:pt idx="3">
                    <c:v>0.71623269480321838</c:v>
                  </c:pt>
                </c:numCache>
              </c:numRef>
            </c:plus>
            <c:minus>
              <c:numRef>
                <c:f>'Other ABCs'!$N$13:$N$16</c:f>
                <c:numCache>
                  <c:formatCode>General</c:formatCode>
                  <c:ptCount val="4"/>
                  <c:pt idx="0">
                    <c:v>8.2121770396226465E-2</c:v>
                  </c:pt>
                  <c:pt idx="1">
                    <c:v>0.10313214910994892</c:v>
                  </c:pt>
                  <c:pt idx="2">
                    <c:v>0.26857802761922173</c:v>
                  </c:pt>
                  <c:pt idx="3">
                    <c:v>0.71623269480321838</c:v>
                  </c:pt>
                </c:numCache>
              </c:numRef>
            </c:minus>
          </c:errBars>
          <c:cat>
            <c:strRef>
              <c:f>'Other ABCs'!$C$3:$C$6</c:f>
              <c:strCache>
                <c:ptCount val="4"/>
                <c:pt idx="0">
                  <c:v>-</c:v>
                </c:pt>
                <c:pt idx="1">
                  <c:v>Cispl</c:v>
                </c:pt>
                <c:pt idx="2">
                  <c:v>iHDAC</c:v>
                </c:pt>
                <c:pt idx="3">
                  <c:v>Cispl + iHDAC</c:v>
                </c:pt>
              </c:strCache>
            </c:strRef>
          </c:cat>
          <c:val>
            <c:numRef>
              <c:f>'Other ABCs'!$J$13:$J$16</c:f>
              <c:numCache>
                <c:formatCode>0\.0000</c:formatCode>
                <c:ptCount val="4"/>
                <c:pt idx="0">
                  <c:v>1.0315184984790491</c:v>
                </c:pt>
                <c:pt idx="1">
                  <c:v>1.3171117861087185</c:v>
                </c:pt>
                <c:pt idx="2">
                  <c:v>1.1258580082902252</c:v>
                </c:pt>
                <c:pt idx="3">
                  <c:v>3.08782508640380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1239424"/>
        <c:axId val="81245312"/>
      </c:barChart>
      <c:catAx>
        <c:axId val="8123942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txPr>
          <a:bodyPr rot="-2700000"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pl-PL"/>
          </a:p>
        </c:txPr>
        <c:crossAx val="81245312"/>
        <c:crosses val="autoZero"/>
        <c:auto val="1"/>
        <c:lblAlgn val="ctr"/>
        <c:lblOffset val="100"/>
        <c:noMultiLvlLbl val="0"/>
      </c:catAx>
      <c:valAx>
        <c:axId val="81245312"/>
        <c:scaling>
          <c:orientation val="minMax"/>
          <c:max val="4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pl-PL"/>
                  <a:t>Fold</a:t>
                </a:r>
                <a:r>
                  <a:rPr lang="pl-PL" baseline="0"/>
                  <a:t> change</a:t>
                </a:r>
                <a:endParaRPr lang="pl-PL"/>
              </a:p>
            </c:rich>
          </c:tx>
          <c:layout>
            <c:manualLayout>
              <c:xMode val="edge"/>
              <c:yMode val="edge"/>
              <c:x val="6.7597800274965631E-3"/>
              <c:y val="0.19986704932911423"/>
            </c:manualLayout>
          </c:layout>
          <c:overlay val="0"/>
        </c:title>
        <c:numFmt formatCode="#,##0.0" sourceLinked="0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txPr>
          <a:bodyPr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pl-PL"/>
          </a:p>
        </c:txPr>
        <c:crossAx val="81239424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1459653671339863"/>
          <c:y val="0.12520273750827876"/>
          <c:w val="0.50155079700403304"/>
          <c:h val="0.5044668944683801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Other ABCs'!$N$22:$N$23</c:f>
                <c:numCache>
                  <c:formatCode>General</c:formatCode>
                  <c:ptCount val="2"/>
                  <c:pt idx="0">
                    <c:v>0.10601785126408438</c:v>
                  </c:pt>
                  <c:pt idx="1">
                    <c:v>0.11804838118378053</c:v>
                  </c:pt>
                </c:numCache>
              </c:numRef>
            </c:plus>
            <c:minus>
              <c:numRef>
                <c:f>'Other ABCs'!$N$22:$N$23</c:f>
                <c:numCache>
                  <c:formatCode>General</c:formatCode>
                  <c:ptCount val="2"/>
                  <c:pt idx="0">
                    <c:v>0.10601785126408438</c:v>
                  </c:pt>
                  <c:pt idx="1">
                    <c:v>0.11804838118378053</c:v>
                  </c:pt>
                </c:numCache>
              </c:numRef>
            </c:minus>
          </c:errBars>
          <c:cat>
            <c:strRef>
              <c:f>'Other ABCs'!$C$22:$C$23</c:f>
              <c:strCache>
                <c:ptCount val="2"/>
                <c:pt idx="0">
                  <c:v>-</c:v>
                </c:pt>
                <c:pt idx="1">
                  <c:v>Cispl + iHDAC</c:v>
                </c:pt>
              </c:strCache>
            </c:strRef>
          </c:cat>
          <c:val>
            <c:numRef>
              <c:f>'Other ABCs'!$J$22:$J$23</c:f>
              <c:numCache>
                <c:formatCode>0\.0000</c:formatCode>
                <c:ptCount val="2"/>
                <c:pt idx="0">
                  <c:v>0.9924084068848753</c:v>
                </c:pt>
                <c:pt idx="1">
                  <c:v>0.735072506250913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7174144"/>
        <c:axId val="87180032"/>
      </c:barChart>
      <c:catAx>
        <c:axId val="8717414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txPr>
          <a:bodyPr rot="-2700000"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pl-PL"/>
          </a:p>
        </c:txPr>
        <c:crossAx val="87180032"/>
        <c:crosses val="autoZero"/>
        <c:auto val="1"/>
        <c:lblAlgn val="ctr"/>
        <c:lblOffset val="100"/>
        <c:noMultiLvlLbl val="0"/>
      </c:catAx>
      <c:valAx>
        <c:axId val="87180032"/>
        <c:scaling>
          <c:orientation val="minMax"/>
          <c:max val="2.4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pl-PL"/>
                  <a:t>Fold</a:t>
                </a:r>
                <a:r>
                  <a:rPr lang="pl-PL" baseline="0"/>
                  <a:t> change</a:t>
                </a:r>
                <a:endParaRPr lang="pl-PL"/>
              </a:p>
            </c:rich>
          </c:tx>
          <c:layout>
            <c:manualLayout>
              <c:xMode val="edge"/>
              <c:yMode val="edge"/>
              <c:x val="6.7597800274965631E-3"/>
              <c:y val="0.19986704932911423"/>
            </c:manualLayout>
          </c:layout>
          <c:overlay val="0"/>
        </c:title>
        <c:numFmt formatCode="#,##0.0" sourceLinked="0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txPr>
          <a:bodyPr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pl-PL"/>
          </a:p>
        </c:txPr>
        <c:crossAx val="87174144"/>
        <c:crosses val="autoZero"/>
        <c:crossBetween val="between"/>
        <c:majorUnit val="0.8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pl-P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1459653671339863"/>
          <c:y val="0.12520273750827876"/>
          <c:w val="0.50155079700403304"/>
          <c:h val="0.5044668944683801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  <a:ln>
              <a:solidFill>
                <a:srgbClr val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Other ABCs'!$N$29:$N$30</c:f>
                <c:numCache>
                  <c:formatCode>General</c:formatCode>
                  <c:ptCount val="2"/>
                  <c:pt idx="0">
                    <c:v>6.7485652621495251E-2</c:v>
                  </c:pt>
                  <c:pt idx="1">
                    <c:v>6.9185129164965609E-2</c:v>
                  </c:pt>
                </c:numCache>
              </c:numRef>
            </c:plus>
            <c:minus>
              <c:numRef>
                <c:f>'Other ABCs'!$N$29:$N$30</c:f>
                <c:numCache>
                  <c:formatCode>General</c:formatCode>
                  <c:ptCount val="2"/>
                  <c:pt idx="0">
                    <c:v>6.7485652621495251E-2</c:v>
                  </c:pt>
                  <c:pt idx="1">
                    <c:v>6.9185129164965609E-2</c:v>
                  </c:pt>
                </c:numCache>
              </c:numRef>
            </c:minus>
          </c:errBars>
          <c:cat>
            <c:strRef>
              <c:f>'Other ABCs'!$C$22:$C$23</c:f>
              <c:strCache>
                <c:ptCount val="2"/>
                <c:pt idx="0">
                  <c:v>-</c:v>
                </c:pt>
                <c:pt idx="1">
                  <c:v>Cispl + iHDAC</c:v>
                </c:pt>
              </c:strCache>
            </c:strRef>
          </c:cat>
          <c:val>
            <c:numRef>
              <c:f>'Other ABCs'!$J$29:$J$30</c:f>
              <c:numCache>
                <c:formatCode>0\.0000</c:formatCode>
                <c:ptCount val="2"/>
                <c:pt idx="0">
                  <c:v>1.0147160322339739</c:v>
                </c:pt>
                <c:pt idx="1">
                  <c:v>0.7752550636204258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96711424"/>
        <c:axId val="96712960"/>
      </c:barChart>
      <c:catAx>
        <c:axId val="9671142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txPr>
          <a:bodyPr rot="-2700000"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pl-PL"/>
          </a:p>
        </c:txPr>
        <c:crossAx val="96712960"/>
        <c:crosses val="autoZero"/>
        <c:auto val="1"/>
        <c:lblAlgn val="ctr"/>
        <c:lblOffset val="100"/>
        <c:noMultiLvlLbl val="0"/>
      </c:catAx>
      <c:valAx>
        <c:axId val="96712960"/>
        <c:scaling>
          <c:orientation val="minMax"/>
          <c:max val="2.4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pl-PL"/>
                  <a:t>Fold</a:t>
                </a:r>
                <a:r>
                  <a:rPr lang="pl-PL" baseline="0"/>
                  <a:t> change</a:t>
                </a:r>
                <a:endParaRPr lang="pl-PL"/>
              </a:p>
            </c:rich>
          </c:tx>
          <c:layout>
            <c:manualLayout>
              <c:xMode val="edge"/>
              <c:yMode val="edge"/>
              <c:x val="6.7597800274965631E-3"/>
              <c:y val="0.19986704932911423"/>
            </c:manualLayout>
          </c:layout>
          <c:overlay val="0"/>
        </c:title>
        <c:numFmt formatCode="#,##0.0" sourceLinked="0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txPr>
          <a:bodyPr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pl-PL"/>
          </a:p>
        </c:txPr>
        <c:crossAx val="96711424"/>
        <c:crosses val="autoZero"/>
        <c:crossBetween val="between"/>
        <c:majorUnit val="0.8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40715-6457-49BC-AA89-1E2C152A3F09}" type="datetimeFigureOut">
              <a:rPr lang="pl-PL" smtClean="0"/>
              <a:t>2022-01-1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472B6-FD1A-4ACE-9827-658FB1FDB06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212434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40715-6457-49BC-AA89-1E2C152A3F09}" type="datetimeFigureOut">
              <a:rPr lang="pl-PL" smtClean="0"/>
              <a:t>2022-01-1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472B6-FD1A-4ACE-9827-658FB1FDB06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704452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40715-6457-49BC-AA89-1E2C152A3F09}" type="datetimeFigureOut">
              <a:rPr lang="pl-PL" smtClean="0"/>
              <a:t>2022-01-1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472B6-FD1A-4ACE-9827-658FB1FDB06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959693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40715-6457-49BC-AA89-1E2C152A3F09}" type="datetimeFigureOut">
              <a:rPr lang="pl-PL" smtClean="0"/>
              <a:t>2022-01-1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472B6-FD1A-4ACE-9827-658FB1FDB06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7825839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40715-6457-49BC-AA89-1E2C152A3F09}" type="datetimeFigureOut">
              <a:rPr lang="pl-PL" smtClean="0"/>
              <a:t>2022-01-1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472B6-FD1A-4ACE-9827-658FB1FDB06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019614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40715-6457-49BC-AA89-1E2C152A3F09}" type="datetimeFigureOut">
              <a:rPr lang="pl-PL" smtClean="0"/>
              <a:t>2022-01-1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472B6-FD1A-4ACE-9827-658FB1FDB06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359642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40715-6457-49BC-AA89-1E2C152A3F09}" type="datetimeFigureOut">
              <a:rPr lang="pl-PL" smtClean="0"/>
              <a:t>2022-01-11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472B6-FD1A-4ACE-9827-658FB1FDB06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768485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40715-6457-49BC-AA89-1E2C152A3F09}" type="datetimeFigureOut">
              <a:rPr lang="pl-PL" smtClean="0"/>
              <a:t>2022-01-11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472B6-FD1A-4ACE-9827-658FB1FDB06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575459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40715-6457-49BC-AA89-1E2C152A3F09}" type="datetimeFigureOut">
              <a:rPr lang="pl-PL" smtClean="0"/>
              <a:t>2022-01-11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472B6-FD1A-4ACE-9827-658FB1FDB06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1048974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40715-6457-49BC-AA89-1E2C152A3F09}" type="datetimeFigureOut">
              <a:rPr lang="pl-PL" smtClean="0"/>
              <a:t>2022-01-1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472B6-FD1A-4ACE-9827-658FB1FDB06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14089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40715-6457-49BC-AA89-1E2C152A3F09}" type="datetimeFigureOut">
              <a:rPr lang="pl-PL" smtClean="0"/>
              <a:t>2022-01-11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472B6-FD1A-4ACE-9827-658FB1FDB06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05555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640715-6457-49BC-AA89-1E2C152A3F09}" type="datetimeFigureOut">
              <a:rPr lang="pl-PL" smtClean="0"/>
              <a:t>2022-01-11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3472B6-FD1A-4ACE-9827-658FB1FDB06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81728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Wykres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1590442"/>
              </p:ext>
            </p:extLst>
          </p:nvPr>
        </p:nvGraphicFramePr>
        <p:xfrm>
          <a:off x="17957" y="657672"/>
          <a:ext cx="1600200" cy="20383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Wykres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6852545"/>
              </p:ext>
            </p:extLst>
          </p:nvPr>
        </p:nvGraphicFramePr>
        <p:xfrm>
          <a:off x="1763162" y="663607"/>
          <a:ext cx="1600200" cy="20383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pole tekstowe 5"/>
          <p:cNvSpPr txBox="1"/>
          <p:nvPr/>
        </p:nvSpPr>
        <p:spPr>
          <a:xfrm>
            <a:off x="818057" y="477992"/>
            <a:ext cx="5693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i="1" u="sng" dirty="0" smtClean="0">
                <a:latin typeface="Arial" pitchFamily="34" charset="0"/>
                <a:cs typeface="Arial" pitchFamily="34" charset="0"/>
              </a:rPr>
              <a:t>ABCC2</a:t>
            </a:r>
            <a:endParaRPr lang="pl-PL" sz="900" i="1" u="sng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pole tekstowe 6"/>
          <p:cNvSpPr txBox="1"/>
          <p:nvPr/>
        </p:nvSpPr>
        <p:spPr>
          <a:xfrm>
            <a:off x="2504626" y="476332"/>
            <a:ext cx="5693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i="1" u="sng" dirty="0" smtClean="0">
                <a:latin typeface="Arial" pitchFamily="34" charset="0"/>
                <a:cs typeface="Arial" pitchFamily="34" charset="0"/>
              </a:rPr>
              <a:t>ABCC5</a:t>
            </a:r>
            <a:endParaRPr lang="pl-PL" sz="900" i="1" u="sng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Nawias otwierający 8"/>
          <p:cNvSpPr/>
          <p:nvPr/>
        </p:nvSpPr>
        <p:spPr>
          <a:xfrm rot="5400000">
            <a:off x="2766460" y="494670"/>
            <a:ext cx="45721" cy="757390"/>
          </a:xfrm>
          <a:prstGeom prst="leftBracket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0" name="Nawias otwierający 9"/>
          <p:cNvSpPr/>
          <p:nvPr/>
        </p:nvSpPr>
        <p:spPr>
          <a:xfrm rot="5400000">
            <a:off x="1036525" y="511875"/>
            <a:ext cx="45721" cy="757390"/>
          </a:xfrm>
          <a:prstGeom prst="leftBracket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1" name="pole tekstowe 10"/>
          <p:cNvSpPr txBox="1"/>
          <p:nvPr/>
        </p:nvSpPr>
        <p:spPr>
          <a:xfrm>
            <a:off x="991877" y="707164"/>
            <a:ext cx="1350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 smtClean="0">
                <a:latin typeface="Arial" pitchFamily="34" charset="0"/>
                <a:cs typeface="Arial" pitchFamily="34" charset="0"/>
              </a:rPr>
              <a:t>*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pole tekstowe 11"/>
          <p:cNvSpPr txBox="1"/>
          <p:nvPr/>
        </p:nvSpPr>
        <p:spPr>
          <a:xfrm>
            <a:off x="2700427" y="692414"/>
            <a:ext cx="1350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 smtClean="0">
                <a:latin typeface="Arial" pitchFamily="34" charset="0"/>
                <a:cs typeface="Arial" pitchFamily="34" charset="0"/>
              </a:rPr>
              <a:t>*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" name="Łącznik prostoliniowy 14"/>
          <p:cNvCxnSpPr/>
          <p:nvPr/>
        </p:nvCxnSpPr>
        <p:spPr>
          <a:xfrm>
            <a:off x="417658" y="341530"/>
            <a:ext cx="275035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pole tekstowe 15"/>
          <p:cNvSpPr txBox="1"/>
          <p:nvPr/>
        </p:nvSpPr>
        <p:spPr>
          <a:xfrm>
            <a:off x="1508143" y="114617"/>
            <a:ext cx="5693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siCTRL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Łącznik prostoliniowy 16"/>
          <p:cNvCxnSpPr/>
          <p:nvPr/>
        </p:nvCxnSpPr>
        <p:spPr>
          <a:xfrm>
            <a:off x="4374105" y="341530"/>
            <a:ext cx="2075283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pole tekstowe 17"/>
          <p:cNvSpPr txBox="1"/>
          <p:nvPr/>
        </p:nvSpPr>
        <p:spPr>
          <a:xfrm>
            <a:off x="5175089" y="124731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sip53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0" name="Wykres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7777874"/>
              </p:ext>
            </p:extLst>
          </p:nvPr>
        </p:nvGraphicFramePr>
        <p:xfrm>
          <a:off x="4147980" y="674193"/>
          <a:ext cx="1257300" cy="20383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1" name="Wykres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2091659"/>
              </p:ext>
            </p:extLst>
          </p:nvPr>
        </p:nvGraphicFramePr>
        <p:xfrm>
          <a:off x="5399520" y="692414"/>
          <a:ext cx="1257300" cy="20383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2" name="pole tekstowe 21"/>
          <p:cNvSpPr txBox="1"/>
          <p:nvPr/>
        </p:nvSpPr>
        <p:spPr>
          <a:xfrm>
            <a:off x="4711196" y="477992"/>
            <a:ext cx="5693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i="1" u="sng" dirty="0" smtClean="0">
                <a:latin typeface="Arial" pitchFamily="34" charset="0"/>
                <a:cs typeface="Arial" pitchFamily="34" charset="0"/>
              </a:rPr>
              <a:t>ABCC2</a:t>
            </a:r>
            <a:endParaRPr lang="pl-PL" sz="900" i="1" u="sng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pole tekstowe 22"/>
          <p:cNvSpPr txBox="1"/>
          <p:nvPr/>
        </p:nvSpPr>
        <p:spPr>
          <a:xfrm>
            <a:off x="5964216" y="458344"/>
            <a:ext cx="5693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900" i="1" u="sng" dirty="0" smtClean="0">
                <a:latin typeface="Arial" pitchFamily="34" charset="0"/>
                <a:cs typeface="Arial" pitchFamily="34" charset="0"/>
              </a:rPr>
              <a:t>ABCC5</a:t>
            </a:r>
            <a:endParaRPr lang="pl-PL" sz="900" i="1" u="sng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Nawias otwierający 23"/>
          <p:cNvSpPr/>
          <p:nvPr/>
        </p:nvSpPr>
        <p:spPr>
          <a:xfrm rot="5400000">
            <a:off x="4965908" y="1249090"/>
            <a:ext cx="45725" cy="300838"/>
          </a:xfrm>
          <a:prstGeom prst="leftBracket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25" name="pole tekstowe 24"/>
          <p:cNvSpPr txBox="1"/>
          <p:nvPr/>
        </p:nvSpPr>
        <p:spPr>
          <a:xfrm>
            <a:off x="4763745" y="1145814"/>
            <a:ext cx="4500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 smtClean="0">
                <a:latin typeface="Arial" pitchFamily="34" charset="0"/>
                <a:cs typeface="Arial" pitchFamily="34" charset="0"/>
              </a:rPr>
              <a:t>ns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pole tekstowe 25"/>
          <p:cNvSpPr txBox="1"/>
          <p:nvPr/>
        </p:nvSpPr>
        <p:spPr>
          <a:xfrm>
            <a:off x="6181402" y="1178013"/>
            <a:ext cx="1350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900" dirty="0" smtClean="0">
                <a:latin typeface="Arial" pitchFamily="34" charset="0"/>
                <a:cs typeface="Arial" pitchFamily="34" charset="0"/>
              </a:rPr>
              <a:t>*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Nawias otwierający 26"/>
          <p:cNvSpPr/>
          <p:nvPr/>
        </p:nvSpPr>
        <p:spPr>
          <a:xfrm rot="5400000">
            <a:off x="6226048" y="1249091"/>
            <a:ext cx="45725" cy="300838"/>
          </a:xfrm>
          <a:prstGeom prst="leftBracket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3" name="Prostokąt 2"/>
          <p:cNvSpPr/>
          <p:nvPr/>
        </p:nvSpPr>
        <p:spPr>
          <a:xfrm>
            <a:off x="188640" y="2861810"/>
            <a:ext cx="643571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l-PL" sz="900" dirty="0" smtClean="0">
                <a:latin typeface="Arial" pitchFamily="34" charset="0"/>
                <a:cs typeface="Arial" pitchFamily="34" charset="0"/>
              </a:rPr>
              <a:t>mRNA of </a:t>
            </a:r>
            <a:r>
              <a:rPr lang="pl-PL" sz="900" i="1" dirty="0" smtClean="0">
                <a:latin typeface="Arial" pitchFamily="34" charset="0"/>
                <a:cs typeface="Arial" pitchFamily="34" charset="0"/>
              </a:rPr>
              <a:t>ABCC2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pl-PL" sz="900" i="1" dirty="0" smtClean="0">
                <a:latin typeface="Arial" pitchFamily="34" charset="0"/>
                <a:cs typeface="Arial" pitchFamily="34" charset="0"/>
              </a:rPr>
              <a:t>ABCC5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was </a:t>
            </a:r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quantified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by </a:t>
            </a:r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TaqMan-based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real-time PCR. Gene </a:t>
            </a:r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expression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was </a:t>
            </a:r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normalized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to </a:t>
            </a:r>
            <a:r>
              <a:rPr lang="pl-PL" sz="900" i="1" dirty="0" smtClean="0">
                <a:latin typeface="Arial" pitchFamily="34" charset="0"/>
                <a:cs typeface="Arial" pitchFamily="34" charset="0"/>
              </a:rPr>
              <a:t>GAPDH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pl-PL" sz="900" i="1" dirty="0" smtClean="0">
                <a:latin typeface="Arial" pitchFamily="34" charset="0"/>
                <a:cs typeface="Arial" pitchFamily="34" charset="0"/>
              </a:rPr>
              <a:t>HPRT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pl-PL" sz="900" i="1" dirty="0" smtClean="0">
                <a:latin typeface="Arial" pitchFamily="34" charset="0"/>
                <a:cs typeface="Arial" pitchFamily="34" charset="0"/>
              </a:rPr>
              <a:t>TBP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. HDAC inhibitor – </a:t>
            </a:r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iHDAC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sodium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butyrate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, 100 </a:t>
            </a:r>
            <a:r>
              <a:rPr lang="el-GR" sz="900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M) was </a:t>
            </a:r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added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for 1 h </a:t>
            </a:r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prior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to 10 </a:t>
            </a:r>
            <a:r>
              <a:rPr lang="el-GR" sz="900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M cisplatin. </a:t>
            </a:r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Cells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were </a:t>
            </a:r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incubated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with </a:t>
            </a:r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alkylating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drug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for 24 h. </a:t>
            </a:r>
          </a:p>
          <a:p>
            <a:r>
              <a:rPr lang="en-US" sz="900" dirty="0" smtClean="0">
                <a:latin typeface="Arial" pitchFamily="34" charset="0"/>
                <a:cs typeface="Arial" pitchFamily="34" charset="0"/>
              </a:rPr>
              <a:t>All </a:t>
            </a:r>
            <a:r>
              <a:rPr lang="en-US" sz="900" dirty="0">
                <a:latin typeface="Arial" pitchFamily="34" charset="0"/>
                <a:cs typeface="Arial" pitchFamily="34" charset="0"/>
              </a:rPr>
              <a:t>of the bars represent the mean of replicates ± SEM. </a:t>
            </a:r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Gaussian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distribution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was </a:t>
            </a:r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analysed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l-PL" sz="900" dirty="0">
                <a:latin typeface="Arial" pitchFamily="34" charset="0"/>
                <a:cs typeface="Arial" pitchFamily="34" charset="0"/>
              </a:rPr>
              <a:t>with </a:t>
            </a:r>
            <a:r>
              <a:rPr lang="pl-PL" sz="900" dirty="0" err="1">
                <a:latin typeface="Arial" pitchFamily="34" charset="0"/>
                <a:cs typeface="Arial" pitchFamily="34" charset="0"/>
              </a:rPr>
              <a:t>Kolmogorov</a:t>
            </a:r>
            <a:r>
              <a:rPr lang="pl-PL" sz="900" dirty="0">
                <a:latin typeface="Arial" pitchFamily="34" charset="0"/>
                <a:cs typeface="Arial" pitchFamily="34" charset="0"/>
              </a:rPr>
              <a:t>–</a:t>
            </a:r>
            <a:r>
              <a:rPr lang="pl-PL" sz="900" dirty="0" err="1">
                <a:latin typeface="Arial" pitchFamily="34" charset="0"/>
                <a:cs typeface="Arial" pitchFamily="34" charset="0"/>
              </a:rPr>
              <a:t>Smirnov</a:t>
            </a:r>
            <a:r>
              <a:rPr lang="pl-PL" sz="900" dirty="0">
                <a:latin typeface="Arial" pitchFamily="34" charset="0"/>
                <a:cs typeface="Arial" pitchFamily="34" charset="0"/>
              </a:rPr>
              <a:t> 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test. </a:t>
            </a:r>
            <a:endParaRPr lang="pl-PL" sz="900" dirty="0">
              <a:latin typeface="Arial" pitchFamily="34" charset="0"/>
              <a:cs typeface="Arial" pitchFamily="34" charset="0"/>
            </a:endParaRPr>
          </a:p>
          <a:p>
            <a:r>
              <a:rPr lang="en-US" sz="900" dirty="0" smtClean="0">
                <a:latin typeface="Arial" pitchFamily="34" charset="0"/>
                <a:cs typeface="Arial" pitchFamily="34" charset="0"/>
              </a:rPr>
              <a:t>Differences </a:t>
            </a:r>
            <a:r>
              <a:rPr lang="en-US" sz="900" dirty="0">
                <a:latin typeface="Arial" pitchFamily="34" charset="0"/>
                <a:cs typeface="Arial" pitchFamily="34" charset="0"/>
              </a:rPr>
              <a:t>in </a:t>
            </a:r>
            <a:r>
              <a:rPr lang="pl-PL" sz="900" dirty="0" smtClean="0">
                <a:latin typeface="Arial" pitchFamily="34" charset="0"/>
                <a:cs typeface="Arial" pitchFamily="34" charset="0"/>
              </a:rPr>
              <a:t>mRNA </a:t>
            </a:r>
            <a:r>
              <a:rPr lang="pl-PL" sz="900" dirty="0" err="1" smtClean="0">
                <a:latin typeface="Arial" pitchFamily="34" charset="0"/>
                <a:cs typeface="Arial" pitchFamily="34" charset="0"/>
              </a:rPr>
              <a:t>level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900" dirty="0">
                <a:latin typeface="Arial" pitchFamily="34" charset="0"/>
                <a:cs typeface="Arial" pitchFamily="34" charset="0"/>
              </a:rPr>
              <a:t>were analyzed with the t-test. </a:t>
            </a:r>
            <a:r>
              <a:rPr lang="en-US" sz="900" dirty="0" smtClean="0">
                <a:latin typeface="Arial" pitchFamily="34" charset="0"/>
                <a:cs typeface="Arial" pitchFamily="34" charset="0"/>
              </a:rPr>
              <a:t>Statistically </a:t>
            </a:r>
            <a:r>
              <a:rPr lang="en-US" sz="900" dirty="0">
                <a:latin typeface="Arial" pitchFamily="34" charset="0"/>
                <a:cs typeface="Arial" pitchFamily="34" charset="0"/>
              </a:rPr>
              <a:t>significant differences between analyzed groups are marked with * when p &lt; 0.05. Detailed statistical analysis can be found in Table S1.</a:t>
            </a:r>
            <a:endParaRPr lang="pl-PL" sz="9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7174785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130</Words>
  <Application>Microsoft Office PowerPoint</Application>
  <PresentationFormat>Pokaz na ekranie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2" baseType="lpstr">
      <vt:lpstr>Motyw pakietu Office</vt:lpstr>
      <vt:lpstr>Prezentacja programu PowerPoint</vt:lpstr>
    </vt:vector>
  </TitlesOfParts>
  <Company>Sil-art Rycho444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Agnieszka Robaszkiewicz</dc:creator>
  <cp:lastModifiedBy>Agnieszka Robaszkiewicz</cp:lastModifiedBy>
  <cp:revision>8</cp:revision>
  <dcterms:created xsi:type="dcterms:W3CDTF">2022-01-11T11:35:12Z</dcterms:created>
  <dcterms:modified xsi:type="dcterms:W3CDTF">2022-01-11T12:35:24Z</dcterms:modified>
</cp:coreProperties>
</file>